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8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61" d="100"/>
          <a:sy n="61" d="100"/>
        </p:scale>
        <p:origin x="-1541" y="-77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7494BDC-55A3-4BA8-8179-A1E1E6EBEC2C}" type="datetimeFigureOut">
              <a:rPr lang="en-GB" smtClean="0"/>
              <a:t>09/03/2013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53934C4-1469-406F-9BD4-BF976DD0557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325135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A8669E-4234-4773-A97A-100181C0369A}" type="datetimeFigureOut">
              <a:rPr lang="en-GB" smtClean="0"/>
              <a:t>09/03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CCB15B-92ED-4D70-B96F-9D2D255998B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0610231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A8669E-4234-4773-A97A-100181C0369A}" type="datetimeFigureOut">
              <a:rPr lang="en-GB" smtClean="0"/>
              <a:t>09/03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CCB15B-92ED-4D70-B96F-9D2D255998B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2525372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A8669E-4234-4773-A97A-100181C0369A}" type="datetimeFigureOut">
              <a:rPr lang="en-GB" smtClean="0"/>
              <a:t>09/03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CCB15B-92ED-4D70-B96F-9D2D255998B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0238492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A8669E-4234-4773-A97A-100181C0369A}" type="datetimeFigureOut">
              <a:rPr lang="en-GB" smtClean="0"/>
              <a:t>09/03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CCB15B-92ED-4D70-B96F-9D2D255998B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7173755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A8669E-4234-4773-A97A-100181C0369A}" type="datetimeFigureOut">
              <a:rPr lang="en-GB" smtClean="0"/>
              <a:t>09/03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CCB15B-92ED-4D70-B96F-9D2D255998B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2343539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A8669E-4234-4773-A97A-100181C0369A}" type="datetimeFigureOut">
              <a:rPr lang="en-GB" smtClean="0"/>
              <a:t>09/03/201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CCB15B-92ED-4D70-B96F-9D2D255998B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5300739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A8669E-4234-4773-A97A-100181C0369A}" type="datetimeFigureOut">
              <a:rPr lang="en-GB" smtClean="0"/>
              <a:t>09/03/2013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CCB15B-92ED-4D70-B96F-9D2D255998B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8925491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A8669E-4234-4773-A97A-100181C0369A}" type="datetimeFigureOut">
              <a:rPr lang="en-GB" smtClean="0"/>
              <a:t>09/03/2013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CCB15B-92ED-4D70-B96F-9D2D255998B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1992711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A8669E-4234-4773-A97A-100181C0369A}" type="datetimeFigureOut">
              <a:rPr lang="en-GB" smtClean="0"/>
              <a:t>09/03/2013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CCB15B-92ED-4D70-B96F-9D2D255998B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4720888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A8669E-4234-4773-A97A-100181C0369A}" type="datetimeFigureOut">
              <a:rPr lang="en-GB" smtClean="0"/>
              <a:t>09/03/201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CCB15B-92ED-4D70-B96F-9D2D255998B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8573033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A8669E-4234-4773-A97A-100181C0369A}" type="datetimeFigureOut">
              <a:rPr lang="en-GB" smtClean="0"/>
              <a:t>09/03/201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CCB15B-92ED-4D70-B96F-9D2D255998B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1187894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EA8669E-4234-4773-A97A-100181C0369A}" type="datetimeFigureOut">
              <a:rPr lang="en-GB" smtClean="0"/>
              <a:t>09/03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4CCB15B-92ED-4D70-B96F-9D2D255998B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0527760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704831473"/>
              </p:ext>
            </p:extLst>
          </p:nvPr>
        </p:nvGraphicFramePr>
        <p:xfrm>
          <a:off x="764704" y="351554"/>
          <a:ext cx="5112568" cy="8252894"/>
        </p:xfrm>
        <a:graphic>
          <a:graphicData uri="http://schemas.openxmlformats.org/drawingml/2006/table">
            <a:tbl>
              <a:tblPr firstRow="1">
                <a:tableStyleId>{9D7B26C5-4107-4FEC-AEDC-1716B250A1EF}</a:tableStyleId>
              </a:tblPr>
              <a:tblGrid>
                <a:gridCol w="3337739"/>
                <a:gridCol w="1774829"/>
              </a:tblGrid>
              <a:tr h="416144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u="none" strike="noStrike" dirty="0">
                          <a:effectLst/>
                        </a:rPr>
                        <a:t>Fold change</a:t>
                      </a:r>
                      <a:br>
                        <a:rPr lang="en-GB" sz="1050" u="none" strike="noStrike" dirty="0">
                          <a:effectLst/>
                        </a:rPr>
                      </a:br>
                      <a:r>
                        <a:rPr lang="en-GB" sz="1050" u="none" strike="noStrike" dirty="0" smtClean="0">
                          <a:effectLst/>
                        </a:rPr>
                        <a:t>(good </a:t>
                      </a:r>
                      <a:r>
                        <a:rPr lang="en-GB" sz="1050" u="none" strike="noStrike" dirty="0">
                          <a:effectLst/>
                        </a:rPr>
                        <a:t>response </a:t>
                      </a:r>
                      <a:r>
                        <a:rPr lang="en-GB" sz="1050" u="none" strike="noStrike" dirty="0" err="1">
                          <a:effectLst/>
                        </a:rPr>
                        <a:t>vs</a:t>
                      </a:r>
                      <a:r>
                        <a:rPr lang="en-GB" sz="1050" u="none" strike="noStrike" dirty="0">
                          <a:effectLst/>
                        </a:rPr>
                        <a:t> </a:t>
                      </a:r>
                      <a:r>
                        <a:rPr lang="en-GB" sz="1050" u="none" strike="noStrike" dirty="0" smtClean="0">
                          <a:effectLst/>
                        </a:rPr>
                        <a:t>no response/inadequate response)</a:t>
                      </a:r>
                      <a:endParaRPr lang="en-GB" sz="105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335" marR="4335" marT="433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u="none" strike="noStrike" dirty="0">
                          <a:effectLst/>
                        </a:rPr>
                        <a:t>Symbol</a:t>
                      </a:r>
                      <a:endParaRPr lang="en-GB" sz="105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335" marR="4335" marT="4335" marB="0" anchor="ctr"/>
                </a:tc>
              </a:tr>
              <a:tr h="104036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8.3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335" marR="4335" marT="433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>
                          <a:effectLst/>
                        </a:rPr>
                        <a:t>IL1R2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335" marR="4335" marT="4335" marB="0" anchor="b"/>
                </a:tc>
              </a:tr>
              <a:tr h="104036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6.2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335" marR="4335" marT="433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>
                          <a:effectLst/>
                        </a:rPr>
                        <a:t>GRB10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335" marR="4335" marT="4335" marB="0" anchor="b"/>
                </a:tc>
              </a:tr>
              <a:tr h="104036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5.4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335" marR="4335" marT="433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CEACAM4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335" marR="4335" marT="4335" marB="0" anchor="b"/>
                </a:tc>
              </a:tr>
              <a:tr h="104036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5.1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335" marR="4335" marT="433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SIPA1L2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335" marR="4335" marT="4335" marB="0" anchor="b"/>
                </a:tc>
              </a:tr>
              <a:tr h="104036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4.5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335" marR="4335" marT="433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BMX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335" marR="4335" marT="4335" marB="0" anchor="b"/>
                </a:tc>
              </a:tr>
              <a:tr h="104036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4.3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335" marR="4335" marT="433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IL1RAP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335" marR="4335" marT="4335" marB="0" anchor="b"/>
                </a:tc>
              </a:tr>
              <a:tr h="104036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4.0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335" marR="4335" marT="433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REPS2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335" marR="4335" marT="4335" marB="0" anchor="b"/>
                </a:tc>
              </a:tr>
              <a:tr h="104036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4.0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335" marR="4335" marT="433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ANXA3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335" marR="4335" marT="4335" marB="0" anchor="b"/>
                </a:tc>
              </a:tr>
              <a:tr h="104036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4.0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335" marR="4335" marT="433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MMP9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335" marR="4335" marT="4335" marB="0" anchor="b"/>
                </a:tc>
              </a:tr>
              <a:tr h="104036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4.0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335" marR="4335" marT="433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PHC2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335" marR="4335" marT="4335" marB="0" anchor="b"/>
                </a:tc>
              </a:tr>
              <a:tr h="104036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3.8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335" marR="4335" marT="433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HAUS4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335" marR="4335" marT="4335" marB="0" anchor="b"/>
                </a:tc>
              </a:tr>
              <a:tr h="104036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3.6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335" marR="4335" marT="433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DUSP1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335" marR="4335" marT="4335" marB="0" anchor="b"/>
                </a:tc>
              </a:tr>
              <a:tr h="104036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3.6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335" marR="4335" marT="433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CA4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335" marR="4335" marT="4335" marB="0" anchor="b"/>
                </a:tc>
              </a:tr>
              <a:tr h="104036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3.4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335" marR="4335" marT="433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SAMSN1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335" marR="4335" marT="4335" marB="0" anchor="b"/>
                </a:tc>
              </a:tr>
              <a:tr h="104036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3.4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335" marR="4335" marT="433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KLHL2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335" marR="4335" marT="4335" marB="0" anchor="b"/>
                </a:tc>
              </a:tr>
              <a:tr h="104036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3.3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335" marR="4335" marT="433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ACSL1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335" marR="4335" marT="4335" marB="0" anchor="b"/>
                </a:tc>
              </a:tr>
              <a:tr h="104036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3.2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335" marR="4335" marT="433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NSUN7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335" marR="4335" marT="4335" marB="0" anchor="b"/>
                </a:tc>
              </a:tr>
              <a:tr h="104036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3.2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335" marR="4335" marT="433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IL18RAP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335" marR="4335" marT="4335" marB="0" anchor="b"/>
                </a:tc>
              </a:tr>
              <a:tr h="104036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3.2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335" marR="4335" marT="433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GNG10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335" marR="4335" marT="4335" marB="0" anchor="b"/>
                </a:tc>
              </a:tr>
              <a:tr h="104036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3.1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335" marR="4335" marT="433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SMAP2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335" marR="4335" marT="4335" marB="0" anchor="b"/>
                </a:tc>
              </a:tr>
              <a:tr h="104036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3.1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335" marR="4335" marT="433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MGAM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335" marR="4335" marT="4335" marB="0" anchor="b"/>
                </a:tc>
              </a:tr>
              <a:tr h="104036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3.1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335" marR="4335" marT="433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LIN7A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335" marR="4335" marT="4335" marB="0" anchor="b"/>
                </a:tc>
              </a:tr>
              <a:tr h="104036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3.1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335" marR="4335" marT="433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IRAK3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335" marR="4335" marT="4335" marB="0" anchor="b"/>
                </a:tc>
              </a:tr>
              <a:tr h="104036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3.0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335" marR="4335" marT="433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USP10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335" marR="4335" marT="4335" marB="0" anchor="b"/>
                </a:tc>
              </a:tr>
              <a:tr h="104036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3.0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335" marR="4335" marT="433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CEBPD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335" marR="4335" marT="4335" marB="0" anchor="b"/>
                </a:tc>
              </a:tr>
              <a:tr h="104036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3.0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335" marR="4335" marT="433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TGFA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335" marR="4335" marT="4335" marB="0" anchor="b"/>
                </a:tc>
              </a:tr>
              <a:tr h="104036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3.0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335" marR="4335" marT="433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FOS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335" marR="4335" marT="4335" marB="0" anchor="b"/>
                </a:tc>
              </a:tr>
              <a:tr h="104036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3.0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335" marR="4335" marT="433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MANSC1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335" marR="4335" marT="4335" marB="0" anchor="b"/>
                </a:tc>
              </a:tr>
              <a:tr h="104036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2.9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335" marR="4335" marT="433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SLC26A8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335" marR="4335" marT="4335" marB="0" anchor="b"/>
                </a:tc>
              </a:tr>
              <a:tr h="104036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2.8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335" marR="4335" marT="433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ROPN1L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335" marR="4335" marT="4335" marB="0" anchor="b"/>
                </a:tc>
              </a:tr>
              <a:tr h="104036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2.8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335" marR="4335" marT="433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GPR97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335" marR="4335" marT="4335" marB="0" anchor="b"/>
                </a:tc>
              </a:tr>
              <a:tr h="104036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2.8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335" marR="4335" marT="433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NAMPT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335" marR="4335" marT="4335" marB="0" anchor="b"/>
                </a:tc>
              </a:tr>
              <a:tr h="104036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2.8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335" marR="4335" marT="433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MRVI1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335" marR="4335" marT="4335" marB="0" anchor="b"/>
                </a:tc>
              </a:tr>
              <a:tr h="104036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2.8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335" marR="4335" marT="433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KCNJ15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335" marR="4335" marT="4335" marB="0" anchor="b"/>
                </a:tc>
              </a:tr>
              <a:tr h="104036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2.7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335" marR="4335" marT="433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KLHL8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335" marR="4335" marT="4335" marB="0" anchor="b"/>
                </a:tc>
              </a:tr>
              <a:tr h="104036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2.7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335" marR="4335" marT="433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GNG10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335" marR="4335" marT="4335" marB="0" anchor="b"/>
                </a:tc>
              </a:tr>
              <a:tr h="104036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2.7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335" marR="4335" marT="433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MEGF9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335" marR="4335" marT="4335" marB="0" anchor="b"/>
                </a:tc>
              </a:tr>
              <a:tr h="104036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2.7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335" marR="4335" marT="433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GPR160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335" marR="4335" marT="4335" marB="0" anchor="b"/>
                </a:tc>
              </a:tr>
              <a:tr h="104036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2.7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335" marR="4335" marT="433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B4GALT5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335" marR="4335" marT="4335" marB="0" anchor="b"/>
                </a:tc>
              </a:tr>
              <a:tr h="104036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2.7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335" marR="4335" marT="433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STEAP4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335" marR="4335" marT="4335" marB="0" anchor="b"/>
                </a:tc>
              </a:tr>
              <a:tr h="104036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2.7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335" marR="4335" marT="433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LRG1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335" marR="4335" marT="4335" marB="0" anchor="b"/>
                </a:tc>
              </a:tr>
              <a:tr h="104036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2.7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335" marR="4335" marT="433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F5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335" marR="4335" marT="4335" marB="0" anchor="b"/>
                </a:tc>
              </a:tr>
              <a:tr h="104036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2.6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335" marR="4335" marT="433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PHTF1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335" marR="4335" marT="4335" marB="0" anchor="b"/>
                </a:tc>
              </a:tr>
              <a:tr h="104036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2.6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335" marR="4335" marT="433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HMGB2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335" marR="4335" marT="4335" marB="0" anchor="b"/>
                </a:tc>
              </a:tr>
              <a:tr h="104036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2.6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335" marR="4335" marT="433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DGAT2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335" marR="4335" marT="4335" marB="0" anchor="b"/>
                </a:tc>
              </a:tr>
              <a:tr h="104036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2.6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335" marR="4335" marT="433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SLC11A1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335" marR="4335" marT="4335" marB="0" anchor="b"/>
                </a:tc>
              </a:tr>
              <a:tr h="104036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2.6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335" marR="4335" marT="433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QPCT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335" marR="4335" marT="4335" marB="0" anchor="b"/>
                </a:tc>
              </a:tr>
              <a:tr h="104036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2.6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335" marR="4335" marT="433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PANX2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335" marR="4335" marT="4335" marB="0" anchor="b"/>
                </a:tc>
              </a:tr>
              <a:tr h="104036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2.6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335" marR="4335" marT="433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GPR141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335" marR="4335" marT="4335" marB="0" anchor="b"/>
                </a:tc>
              </a:tr>
              <a:tr h="104036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2.6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335" marR="4335" marT="433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>
                          <a:effectLst/>
                        </a:rPr>
                        <a:t>LMNB1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335" marR="4335" marT="4335" marB="0" anchor="b"/>
                </a:tc>
              </a:tr>
            </a:tbl>
          </a:graphicData>
        </a:graphic>
      </p:graphicFrame>
      <p:sp>
        <p:nvSpPr>
          <p:cNvPr id="5" name="TextBox 4"/>
          <p:cNvSpPr txBox="1"/>
          <p:nvPr/>
        </p:nvSpPr>
        <p:spPr>
          <a:xfrm>
            <a:off x="7785" y="-36512"/>
            <a:ext cx="126876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 smtClean="0"/>
              <a:t>Table </a:t>
            </a:r>
            <a:r>
              <a:rPr lang="en-GB" b="1" dirty="0" smtClean="0"/>
              <a:t>S8</a:t>
            </a:r>
            <a:endParaRPr lang="en-GB" b="1" dirty="0"/>
          </a:p>
        </p:txBody>
      </p:sp>
    </p:spTree>
    <p:extLst>
      <p:ext uri="{BB962C8B-B14F-4D97-AF65-F5344CB8AC3E}">
        <p14:creationId xmlns:p14="http://schemas.microsoft.com/office/powerpoint/2010/main" val="156316195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0</TotalTime>
  <Words>105</Words>
  <Application>Microsoft Office PowerPoint</Application>
  <PresentationFormat>On-screen Show (4:3)</PresentationFormat>
  <Paragraphs>103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loom</dc:creator>
  <cp:lastModifiedBy>Bloom</cp:lastModifiedBy>
  <cp:revision>9</cp:revision>
  <dcterms:created xsi:type="dcterms:W3CDTF">2013-03-09T22:22:05Z</dcterms:created>
  <dcterms:modified xsi:type="dcterms:W3CDTF">2013-03-09T22:33:02Z</dcterms:modified>
</cp:coreProperties>
</file>